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6" r:id="rId4"/>
  </p:sldIdLst>
  <p:sldSz cx="12192000" cy="6858000"/>
  <p:notesSz cx="6858000" cy="9144000"/>
  <p:defaultTextStyle>
    <a:defPPr>
      <a:defRPr lang="LID4096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629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A7E1F7-083B-32EF-6353-C7CC288AC6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BAF68E2-7D93-79E2-A96C-7EB8A788AF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4A36A5-B3BF-FF9E-3B52-84C276331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9D2B6-BA78-461A-87D3-8A6C65512849}" type="datetimeFigureOut">
              <a:rPr lang="LID4096" smtClean="0"/>
              <a:t>05/01/2023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E1EBDB-A1E9-5085-6C03-E04AE20C3A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0E3433-B208-BDA4-440A-D4313EF46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1D240-E19A-4E74-BFE6-BC591FC1865A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423942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36EB9B-64FD-70E8-8F65-A0633BED98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3A9485-4BAB-11CF-31A1-39B771569E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E781C0-1F45-5160-64CC-6A98324AE6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9D2B6-BA78-461A-87D3-8A6C65512849}" type="datetimeFigureOut">
              <a:rPr lang="LID4096" smtClean="0"/>
              <a:t>05/01/2023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1B2A09-8113-9548-5A4B-85AA14D366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0F87E7-D468-C396-515F-4B412C033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1D240-E19A-4E74-BFE6-BC591FC1865A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845819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ACDB25B-FB0A-A2B3-1A4C-67D45799F5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4A31DD-1D55-6143-8DBD-B2D4577F14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DD7182-B6E8-5781-2860-9223475AA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9D2B6-BA78-461A-87D3-8A6C65512849}" type="datetimeFigureOut">
              <a:rPr lang="LID4096" smtClean="0"/>
              <a:t>05/01/2023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BE2B7-8367-89C9-E4FD-949238ADF3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333DD1-A3B9-D144-E917-91D1D44A4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1D240-E19A-4E74-BFE6-BC591FC1865A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364890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3742D0-C360-22AB-2DF0-6FC64F2482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9C91A8-55F1-D546-32F8-8C7453E11D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8084B-FD1A-96B9-25C4-8DFBE9894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9D2B6-BA78-461A-87D3-8A6C65512849}" type="datetimeFigureOut">
              <a:rPr lang="LID4096" smtClean="0"/>
              <a:t>05/01/2023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F7EA27-BE5C-7328-594F-5A50432641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79ADF4-8D0C-55DE-67BE-B6BB5DAA5D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1D240-E19A-4E74-BFE6-BC591FC1865A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4004189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75DEF8-03F3-B161-1FBF-4BE6BACABF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D3B067-999F-AA20-7910-604598179A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299A91-88E6-8B84-31B4-2CEB858C2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9D2B6-BA78-461A-87D3-8A6C65512849}" type="datetimeFigureOut">
              <a:rPr lang="LID4096" smtClean="0"/>
              <a:t>05/01/2023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0EE421-CE11-4A21-27BB-C1400F725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134DD6-27A7-AA73-EE26-8AC0ED0093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1D240-E19A-4E74-BFE6-BC591FC1865A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032666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F02904-0341-B5D6-56DA-59B2300AB2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F21B2A-F951-3DD9-9EDD-CC2A7619DC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A91B54-E1D7-AC1A-8E0C-427D5EF719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8A911A-3CE0-87B7-28EB-DB111AD273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9D2B6-BA78-461A-87D3-8A6C65512849}" type="datetimeFigureOut">
              <a:rPr lang="LID4096" smtClean="0"/>
              <a:t>05/01/2023</a:t>
            </a:fld>
            <a:endParaRPr lang="LID4096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091090-E0A5-0614-CB25-748F32EC7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8A6FF7-6FF9-3CAA-4984-6353173F40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1D240-E19A-4E74-BFE6-BC591FC1865A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446098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D5AC6A-D3B0-042C-B126-90013849BF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19429D-E1C8-B511-692B-968A785558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FFBB19-D755-BFEC-16B9-6275597999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EEF35F-1E1B-9B28-8EA7-F87EAD4913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DA6E8EC-B277-247A-63D6-FEB62E57E5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37C3F32-1AC5-EE37-6D94-B94A8E8D8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9D2B6-BA78-461A-87D3-8A6C65512849}" type="datetimeFigureOut">
              <a:rPr lang="LID4096" smtClean="0"/>
              <a:t>05/01/2023</a:t>
            </a:fld>
            <a:endParaRPr lang="LID4096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CA5198-07E7-27F1-5BD6-566FA76AA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AFB284-652B-38B9-2B8C-10BF784E4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1D240-E19A-4E74-BFE6-BC591FC1865A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224616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F625AD-C803-7205-8FE6-0BB8D5BA7E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3B87260-91C3-59D7-5FF3-85B89DBA3F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9D2B6-BA78-461A-87D3-8A6C65512849}" type="datetimeFigureOut">
              <a:rPr lang="LID4096" smtClean="0"/>
              <a:t>05/01/2023</a:t>
            </a:fld>
            <a:endParaRPr lang="LID4096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56C125-3279-3BB1-E37F-CB1AA0A61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1F689A5-9E29-08AF-5573-78BCB3D53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1D240-E19A-4E74-BFE6-BC591FC1865A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615198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6C08D7D-038C-FD01-3F39-A4DF05A74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9D2B6-BA78-461A-87D3-8A6C65512849}" type="datetimeFigureOut">
              <a:rPr lang="LID4096" smtClean="0"/>
              <a:t>05/01/2023</a:t>
            </a:fld>
            <a:endParaRPr lang="LID4096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6CA5AF6-BFF9-E25E-9F28-50AF3B274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C4D4FB-B770-0D13-1B8E-AB05E2AE3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1D240-E19A-4E74-BFE6-BC591FC1865A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727206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2F187F-5E07-4591-99A4-C0D0220B0F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969349-4177-D7D6-90B0-CA21798FD7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09CB08-ED68-5566-BCC6-6D4B1134E6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FD9F3B-792D-A090-0E84-BAAD8BBD2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9D2B6-BA78-461A-87D3-8A6C65512849}" type="datetimeFigureOut">
              <a:rPr lang="LID4096" smtClean="0"/>
              <a:t>05/01/2023</a:t>
            </a:fld>
            <a:endParaRPr lang="LID4096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AF3390-D141-D1E6-6F2A-7FD88B405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9CCFE1-1498-0740-74C7-0CEA6BC6EB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1D240-E19A-4E74-BFE6-BC591FC1865A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983644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D152E0-0C26-3D82-1BA7-4C8D0BD811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FB6A5A-12D0-D4DB-2DF8-7D5D693F32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LID4096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9C420D-F87B-7E95-591F-7A676D4484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8EB989-EC02-0DAE-E220-BD1593CEF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9D2B6-BA78-461A-87D3-8A6C65512849}" type="datetimeFigureOut">
              <a:rPr lang="LID4096" smtClean="0"/>
              <a:t>05/01/2023</a:t>
            </a:fld>
            <a:endParaRPr lang="LID4096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4BC475-C009-61B2-C751-D21604273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308D56-6C87-C1AB-2D1C-786CB013D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1D240-E19A-4E74-BFE6-BC591FC1865A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323306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2C62B50-49E3-B592-E5FF-15D8AF2771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FB2FD5-CBE6-865F-8A8D-A4758642B8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E5196B-3B98-CA61-422C-F16D475E63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9D2B6-BA78-461A-87D3-8A6C65512849}" type="datetimeFigureOut">
              <a:rPr lang="LID4096" smtClean="0"/>
              <a:t>05/01/2023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B71684-F4D2-9B62-15A2-1ABF726CCE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606F0C-636D-D6BC-3FFA-DB9D062A23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11D240-E19A-4E74-BFE6-BC591FC1865A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688857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LID4096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CCADDBE-9E6C-3D51-FEC3-8BA8C49905AF}"/>
              </a:ext>
            </a:extLst>
          </p:cNvPr>
          <p:cNvSpPr txBox="1"/>
          <p:nvPr/>
        </p:nvSpPr>
        <p:spPr>
          <a:xfrm>
            <a:off x="8441871" y="195572"/>
            <a:ext cx="6097554" cy="31393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	WPT-665480</a:t>
            </a:r>
          </a:p>
          <a:p>
            <a:r>
              <a:rPr lang="en-US" dirty="0"/>
              <a:t>2	WPT-3738</a:t>
            </a:r>
          </a:p>
          <a:p>
            <a:r>
              <a:rPr lang="en-US" dirty="0"/>
              <a:t>3	WPT-7953</a:t>
            </a:r>
          </a:p>
          <a:p>
            <a:r>
              <a:rPr lang="en-US" dirty="0"/>
              <a:t>4	WPT-2206</a:t>
            </a:r>
          </a:p>
          <a:p>
            <a:r>
              <a:rPr lang="en-US" dirty="0"/>
              <a:t>5	WPT-3790</a:t>
            </a:r>
          </a:p>
          <a:p>
            <a:r>
              <a:rPr lang="en-US" dirty="0"/>
              <a:t>6	WPT-4196</a:t>
            </a:r>
          </a:p>
          <a:p>
            <a:r>
              <a:rPr lang="en-US" dirty="0"/>
              <a:t>7	WPT-8960</a:t>
            </a:r>
          </a:p>
          <a:p>
            <a:r>
              <a:rPr lang="en-US" dirty="0"/>
              <a:t>8	WPT-9664</a:t>
            </a:r>
          </a:p>
          <a:p>
            <a:pPr marL="342900" indent="-342900">
              <a:buAutoNum type="arabicPlain" startAt="9"/>
            </a:pPr>
            <a:r>
              <a:rPr lang="en-US" dirty="0"/>
              <a:t>           WPT-9380				</a:t>
            </a:r>
          </a:p>
          <a:p>
            <a:pPr marL="342900" indent="-342900">
              <a:buAutoNum type="arabicPlain" startAt="9"/>
            </a:pPr>
            <a:r>
              <a:rPr lang="en-US" dirty="0">
                <a:solidFill>
                  <a:srgbClr val="FF0000"/>
                </a:solidFill>
              </a:rPr>
              <a:t>           WPT-729788</a:t>
            </a:r>
            <a:r>
              <a:rPr lang="en-US" dirty="0"/>
              <a:t>										</a:t>
            </a:r>
          </a:p>
        </p:txBody>
      </p:sp>
      <p:pic>
        <p:nvPicPr>
          <p:cNvPr id="8" name="Picture 7" descr="Table&#10;&#10;Description automatically generated">
            <a:extLst>
              <a:ext uri="{FF2B5EF4-FFF2-40B4-BE49-F238E27FC236}">
                <a16:creationId xmlns:a16="http://schemas.microsoft.com/office/drawing/2014/main" id="{73EEA06D-1594-E60E-0396-4CDE93736C1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7" t="7046" r="14160" b="10148"/>
          <a:stretch/>
        </p:blipFill>
        <p:spPr>
          <a:xfrm>
            <a:off x="130628" y="97972"/>
            <a:ext cx="7013510" cy="436206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55CF06E-27F4-D607-EDA2-05A4E919C4D3}"/>
              </a:ext>
            </a:extLst>
          </p:cNvPr>
          <p:cNvSpPr txBox="1"/>
          <p:nvPr/>
        </p:nvSpPr>
        <p:spPr>
          <a:xfrm>
            <a:off x="214605" y="5389687"/>
            <a:ext cx="110101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1: Haplotype analysis based on D prime among all </a:t>
            </a:r>
            <a:r>
              <a:rPr lang="en-US" dirty="0" err="1"/>
              <a:t>DArT</a:t>
            </a:r>
            <a:r>
              <a:rPr lang="en-US" dirty="0"/>
              <a:t> SNPs located on 1D chromosome. Red marker refers to a validated significant marker</a:t>
            </a:r>
            <a:endParaRPr lang="LID4096" dirty="0"/>
          </a:p>
        </p:txBody>
      </p:sp>
    </p:spTree>
    <p:extLst>
      <p:ext uri="{BB962C8B-B14F-4D97-AF65-F5344CB8AC3E}">
        <p14:creationId xmlns:p14="http://schemas.microsoft.com/office/powerpoint/2010/main" val="40225512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calendar&#10;&#10;Description automatically generated">
            <a:extLst>
              <a:ext uri="{FF2B5EF4-FFF2-40B4-BE49-F238E27FC236}">
                <a16:creationId xmlns:a16="http://schemas.microsoft.com/office/drawing/2014/main" id="{4875389E-0B94-A1F4-D899-09FF7189EF8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68" t="6660" r="26310" b="23097"/>
          <a:stretch/>
        </p:blipFill>
        <p:spPr>
          <a:xfrm>
            <a:off x="289249" y="214602"/>
            <a:ext cx="5181600" cy="336349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2436000-CD49-30FB-70BA-6AF4FB54BB17}"/>
              </a:ext>
            </a:extLst>
          </p:cNvPr>
          <p:cNvSpPr txBox="1"/>
          <p:nvPr/>
        </p:nvSpPr>
        <p:spPr>
          <a:xfrm>
            <a:off x="7574125" y="601739"/>
            <a:ext cx="6097554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	WPT-7466</a:t>
            </a:r>
          </a:p>
          <a:p>
            <a:r>
              <a:rPr lang="en-US" dirty="0"/>
              <a:t>2	WPT-1301</a:t>
            </a:r>
          </a:p>
          <a:p>
            <a:r>
              <a:rPr lang="en-US" dirty="0"/>
              <a:t>3	WPT-4329</a:t>
            </a:r>
          </a:p>
          <a:p>
            <a:r>
              <a:rPr lang="en-US" dirty="0">
                <a:solidFill>
                  <a:srgbClr val="FF0000"/>
                </a:solidFill>
              </a:rPr>
              <a:t>4	WPT-6064</a:t>
            </a:r>
          </a:p>
          <a:p>
            <a:r>
              <a:rPr lang="en-US" dirty="0"/>
              <a:t>5	WPT-7921</a:t>
            </a:r>
          </a:p>
          <a:p>
            <a:r>
              <a:rPr lang="en-US" dirty="0"/>
              <a:t>6	WPT-424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7F7C89A-8926-AA81-B0D3-5B65CFAD2812}"/>
              </a:ext>
            </a:extLst>
          </p:cNvPr>
          <p:cNvSpPr txBox="1"/>
          <p:nvPr/>
        </p:nvSpPr>
        <p:spPr>
          <a:xfrm>
            <a:off x="214605" y="5389687"/>
            <a:ext cx="110101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2: Haplotype analysis based on D prime among all </a:t>
            </a:r>
            <a:r>
              <a:rPr lang="en-US" dirty="0" err="1"/>
              <a:t>DArT</a:t>
            </a:r>
            <a:r>
              <a:rPr lang="en-US" dirty="0"/>
              <a:t> SNPs located on 2D chromosome. Red marker refers to a validated significant marker</a:t>
            </a:r>
            <a:endParaRPr lang="LID4096" dirty="0"/>
          </a:p>
        </p:txBody>
      </p:sp>
    </p:spTree>
    <p:extLst>
      <p:ext uri="{BB962C8B-B14F-4D97-AF65-F5344CB8AC3E}">
        <p14:creationId xmlns:p14="http://schemas.microsoft.com/office/powerpoint/2010/main" val="33838600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35E408E-DFD6-D940-8EAB-57482756161B}"/>
              </a:ext>
            </a:extLst>
          </p:cNvPr>
          <p:cNvSpPr txBox="1"/>
          <p:nvPr/>
        </p:nvSpPr>
        <p:spPr>
          <a:xfrm>
            <a:off x="9519750" y="653854"/>
            <a:ext cx="2924176" cy="35394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1	WPT-4569</a:t>
            </a:r>
          </a:p>
          <a:p>
            <a:r>
              <a:rPr lang="en-US" sz="1400" b="1" dirty="0"/>
              <a:t>2	</a:t>
            </a:r>
            <a:r>
              <a:rPr lang="en-US" sz="1400" b="1" dirty="0">
                <a:solidFill>
                  <a:srgbClr val="FF0000"/>
                </a:solidFill>
              </a:rPr>
              <a:t>WPT-742148</a:t>
            </a:r>
          </a:p>
          <a:p>
            <a:r>
              <a:rPr lang="en-US" sz="1400" b="1" dirty="0"/>
              <a:t>3	WPT-742</a:t>
            </a:r>
            <a:r>
              <a:rPr lang="en-US" sz="1400" b="1" dirty="0">
                <a:solidFill>
                  <a:srgbClr val="FF0000"/>
                </a:solidFill>
              </a:rPr>
              <a:t>530</a:t>
            </a:r>
          </a:p>
          <a:p>
            <a:r>
              <a:rPr lang="en-US" sz="1400" b="1" dirty="0"/>
              <a:t>4	WPT-2013</a:t>
            </a:r>
          </a:p>
          <a:p>
            <a:r>
              <a:rPr lang="en-US" sz="1400" b="1" dirty="0"/>
              <a:t>5	WPT-740662</a:t>
            </a:r>
          </a:p>
          <a:p>
            <a:r>
              <a:rPr lang="en-US" sz="1400" b="1" dirty="0"/>
              <a:t>6	WPT-740803</a:t>
            </a:r>
          </a:p>
          <a:p>
            <a:r>
              <a:rPr lang="en-US" sz="1400" b="1" dirty="0"/>
              <a:t>7	WPT-741800</a:t>
            </a:r>
          </a:p>
          <a:p>
            <a:r>
              <a:rPr lang="en-US" sz="1400" b="1" dirty="0"/>
              <a:t>8	WPT-741987</a:t>
            </a:r>
          </a:p>
          <a:p>
            <a:r>
              <a:rPr lang="en-US" sz="1400" b="1" dirty="0"/>
              <a:t>9	WPT-3412</a:t>
            </a:r>
          </a:p>
          <a:p>
            <a:r>
              <a:rPr lang="en-US" sz="1400" b="1" dirty="0"/>
              <a:t>10	</a:t>
            </a:r>
            <a:r>
              <a:rPr lang="en-US" sz="1400" b="1" dirty="0">
                <a:solidFill>
                  <a:srgbClr val="FF0000"/>
                </a:solidFill>
              </a:rPr>
              <a:t>WPT-740873</a:t>
            </a:r>
          </a:p>
          <a:p>
            <a:r>
              <a:rPr lang="en-US" sz="1400" b="1" dirty="0"/>
              <a:t>11	</a:t>
            </a:r>
            <a:r>
              <a:rPr lang="en-US" sz="1400" b="1" dirty="0">
                <a:solidFill>
                  <a:srgbClr val="FF0000"/>
                </a:solidFill>
              </a:rPr>
              <a:t>WPT-742443</a:t>
            </a:r>
          </a:p>
          <a:p>
            <a:r>
              <a:rPr lang="en-US" sz="1400" b="1" dirty="0"/>
              <a:t>12	WPT-666681</a:t>
            </a:r>
          </a:p>
          <a:p>
            <a:r>
              <a:rPr lang="en-US" sz="1400" b="1" dirty="0"/>
              <a:t>13	WPT-741108</a:t>
            </a:r>
          </a:p>
          <a:p>
            <a:r>
              <a:rPr lang="en-US" sz="1400" b="1" dirty="0"/>
              <a:t>14	WPT-4476</a:t>
            </a:r>
          </a:p>
          <a:p>
            <a:r>
              <a:rPr lang="en-US" sz="1400" b="1" dirty="0"/>
              <a:t>15	WPT-0485</a:t>
            </a:r>
          </a:p>
          <a:p>
            <a:r>
              <a:rPr lang="en-US" sz="1400" b="1" dirty="0"/>
              <a:t>16	WPT-2923</a:t>
            </a:r>
          </a:p>
        </p:txBody>
      </p:sp>
      <p:pic>
        <p:nvPicPr>
          <p:cNvPr id="9" name="Picture 8" descr="A picture containing table&#10;&#10;Description automatically generated">
            <a:extLst>
              <a:ext uri="{FF2B5EF4-FFF2-40B4-BE49-F238E27FC236}">
                <a16:creationId xmlns:a16="http://schemas.microsoft.com/office/drawing/2014/main" id="{26D9B015-93AD-1AD6-36AF-02BC933A5F9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06" t="8039" r="15738" b="3549"/>
          <a:stretch/>
        </p:blipFill>
        <p:spPr>
          <a:xfrm>
            <a:off x="-1" y="0"/>
            <a:ext cx="9050229" cy="510384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80C6C67-453D-0ED4-411F-83EF546A0E98}"/>
              </a:ext>
            </a:extLst>
          </p:cNvPr>
          <p:cNvSpPr txBox="1"/>
          <p:nvPr/>
        </p:nvSpPr>
        <p:spPr>
          <a:xfrm>
            <a:off x="214605" y="5389687"/>
            <a:ext cx="110101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3: Haplotype analysis based on D prime among all </a:t>
            </a:r>
            <a:r>
              <a:rPr lang="en-US" dirty="0" err="1"/>
              <a:t>DArT</a:t>
            </a:r>
            <a:r>
              <a:rPr lang="en-US" dirty="0"/>
              <a:t> SNPs located on 3D chromosome. Red marker refers to a validated significant marker</a:t>
            </a:r>
            <a:endParaRPr lang="LID4096" dirty="0"/>
          </a:p>
        </p:txBody>
      </p:sp>
    </p:spTree>
    <p:extLst>
      <p:ext uri="{BB962C8B-B14F-4D97-AF65-F5344CB8AC3E}">
        <p14:creationId xmlns:p14="http://schemas.microsoft.com/office/powerpoint/2010/main" val="3860576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9</Words>
  <Application>Microsoft Office PowerPoint</Application>
  <PresentationFormat>Widescreen</PresentationFormat>
  <Paragraphs>3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Ahmed Sallam</dc:creator>
  <cp:lastModifiedBy>Dr. Ahmed Sallam</cp:lastModifiedBy>
  <cp:revision>1</cp:revision>
  <dcterms:created xsi:type="dcterms:W3CDTF">2023-05-01T08:42:08Z</dcterms:created>
  <dcterms:modified xsi:type="dcterms:W3CDTF">2023-05-01T09:43:03Z</dcterms:modified>
</cp:coreProperties>
</file>